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6" r:id="rId3"/>
    <p:sldId id="258" r:id="rId4"/>
    <p:sldId id="259" r:id="rId5"/>
    <p:sldId id="260" r:id="rId6"/>
    <p:sldId id="261" r:id="rId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50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D2D14-4F08-4C88-A2C6-DF53214A013C}" type="datetimeFigureOut">
              <a:rPr lang="en-US" smtClean="0"/>
              <a:t>10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B2A76-F47C-4ABA-9D82-6214635B89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33125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D2D14-4F08-4C88-A2C6-DF53214A013C}" type="datetimeFigureOut">
              <a:rPr lang="en-US" smtClean="0"/>
              <a:t>10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B2A76-F47C-4ABA-9D82-6214635B89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91507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D2D14-4F08-4C88-A2C6-DF53214A013C}" type="datetimeFigureOut">
              <a:rPr lang="en-US" smtClean="0"/>
              <a:t>10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B2A76-F47C-4ABA-9D82-6214635B89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50148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D2D14-4F08-4C88-A2C6-DF53214A013C}" type="datetimeFigureOut">
              <a:rPr lang="en-US" smtClean="0"/>
              <a:t>10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B2A76-F47C-4ABA-9D82-6214635B89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28834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D2D14-4F08-4C88-A2C6-DF53214A013C}" type="datetimeFigureOut">
              <a:rPr lang="en-US" smtClean="0"/>
              <a:t>10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B2A76-F47C-4ABA-9D82-6214635B89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92734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D2D14-4F08-4C88-A2C6-DF53214A013C}" type="datetimeFigureOut">
              <a:rPr lang="en-US" smtClean="0"/>
              <a:t>10/1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B2A76-F47C-4ABA-9D82-6214635B89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25407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D2D14-4F08-4C88-A2C6-DF53214A013C}" type="datetimeFigureOut">
              <a:rPr lang="en-US" smtClean="0"/>
              <a:t>10/16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B2A76-F47C-4ABA-9D82-6214635B89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81090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D2D14-4F08-4C88-A2C6-DF53214A013C}" type="datetimeFigureOut">
              <a:rPr lang="en-US" smtClean="0"/>
              <a:t>10/16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B2A76-F47C-4ABA-9D82-6214635B89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36735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D2D14-4F08-4C88-A2C6-DF53214A013C}" type="datetimeFigureOut">
              <a:rPr lang="en-US" smtClean="0"/>
              <a:t>10/16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B2A76-F47C-4ABA-9D82-6214635B89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66852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D2D14-4F08-4C88-A2C6-DF53214A013C}" type="datetimeFigureOut">
              <a:rPr lang="en-US" smtClean="0"/>
              <a:t>10/1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B2A76-F47C-4ABA-9D82-6214635B89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18549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D2D14-4F08-4C88-A2C6-DF53214A013C}" type="datetimeFigureOut">
              <a:rPr lang="en-US" smtClean="0"/>
              <a:t>10/1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B2A76-F47C-4ABA-9D82-6214635B89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22242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9D2D14-4F08-4C88-A2C6-DF53214A013C}" type="datetimeFigureOut">
              <a:rPr lang="en-US" smtClean="0"/>
              <a:t>10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6B2A76-F47C-4ABA-9D82-6214635B89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61602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32FEEB01-B569-460F-6601-1D463DC3665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77923363"/>
              </p:ext>
            </p:extLst>
          </p:nvPr>
        </p:nvGraphicFramePr>
        <p:xfrm>
          <a:off x="1967073" y="353792"/>
          <a:ext cx="4833255" cy="432738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966651">
                  <a:extLst>
                    <a:ext uri="{9D8B030D-6E8A-4147-A177-3AD203B41FA5}">
                      <a16:colId xmlns:a16="http://schemas.microsoft.com/office/drawing/2014/main" val="630714373"/>
                    </a:ext>
                  </a:extLst>
                </a:gridCol>
                <a:gridCol w="966651">
                  <a:extLst>
                    <a:ext uri="{9D8B030D-6E8A-4147-A177-3AD203B41FA5}">
                      <a16:colId xmlns:a16="http://schemas.microsoft.com/office/drawing/2014/main" val="2334880184"/>
                    </a:ext>
                  </a:extLst>
                </a:gridCol>
                <a:gridCol w="966651">
                  <a:extLst>
                    <a:ext uri="{9D8B030D-6E8A-4147-A177-3AD203B41FA5}">
                      <a16:colId xmlns:a16="http://schemas.microsoft.com/office/drawing/2014/main" val="377910219"/>
                    </a:ext>
                  </a:extLst>
                </a:gridCol>
                <a:gridCol w="966651">
                  <a:extLst>
                    <a:ext uri="{9D8B030D-6E8A-4147-A177-3AD203B41FA5}">
                      <a16:colId xmlns:a16="http://schemas.microsoft.com/office/drawing/2014/main" val="1513624534"/>
                    </a:ext>
                  </a:extLst>
                </a:gridCol>
                <a:gridCol w="966651">
                  <a:extLst>
                    <a:ext uri="{9D8B030D-6E8A-4147-A177-3AD203B41FA5}">
                      <a16:colId xmlns:a16="http://schemas.microsoft.com/office/drawing/2014/main" val="579366324"/>
                    </a:ext>
                  </a:extLst>
                </a:gridCol>
              </a:tblGrid>
              <a:tr h="218113"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Patient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Ag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Gender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Group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Treatment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91501525"/>
                  </a:ext>
                </a:extLst>
              </a:tr>
              <a:tr h="218113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4615785"/>
                  </a:ext>
                </a:extLst>
              </a:tr>
              <a:tr h="238502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HC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35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HC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Untreated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40057265"/>
                  </a:ext>
                </a:extLst>
              </a:tr>
              <a:tr h="226686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HC2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33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HC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Untreated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1381508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HC3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36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HC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Untreated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06518034"/>
                  </a:ext>
                </a:extLst>
              </a:tr>
              <a:tr h="271021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HC4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4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3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HC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Untreated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80092367"/>
                  </a:ext>
                </a:extLst>
              </a:tr>
              <a:tr h="249382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HC5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4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5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HC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Untreated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47438631"/>
                  </a:ext>
                </a:extLst>
              </a:tr>
              <a:tr h="257694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HC6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2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7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M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HC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Untreated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58584256"/>
                  </a:ext>
                </a:extLst>
              </a:tr>
              <a:tr h="257695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HC7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3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HC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Untreated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0423136"/>
                  </a:ext>
                </a:extLst>
              </a:tr>
              <a:tr h="221672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HC8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28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HC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Untreated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62270837"/>
                  </a:ext>
                </a:extLst>
              </a:tr>
              <a:tr h="235527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HC9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2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7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HC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Untreated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50220081"/>
                  </a:ext>
                </a:extLst>
              </a:tr>
              <a:tr h="224443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HC1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2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6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HC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Untreated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71262542"/>
                  </a:ext>
                </a:extLst>
              </a:tr>
              <a:tr h="221672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HC1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3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6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F</a:t>
                      </a: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emal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HC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Untreated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8159637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HC12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26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HC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Untreated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00891407"/>
                  </a:ext>
                </a:extLst>
              </a:tr>
              <a:tr h="249382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HC13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38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HC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Untreated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33151834"/>
                  </a:ext>
                </a:extLst>
              </a:tr>
              <a:tr h="249381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HC14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28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HC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Untreated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45920547"/>
                  </a:ext>
                </a:extLst>
              </a:tr>
              <a:tr h="354434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HC15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30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HC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Untreated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56027941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6C8BC0E6-AED6-23D2-A9D5-E35469A09258}"/>
              </a:ext>
            </a:extLst>
          </p:cNvPr>
          <p:cNvSpPr txBox="1"/>
          <p:nvPr/>
        </p:nvSpPr>
        <p:spPr>
          <a:xfrm>
            <a:off x="952933" y="5123105"/>
            <a:ext cx="6633557" cy="2539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50" dirty="0">
                <a:latin typeface="Palatino Linotype" panose="02040502050505030304" pitchFamily="18" charset="0"/>
              </a:rPr>
              <a:t>Supplementary Table S1. Demographics of all healthy controls (HC) including gender, age and treatment. </a:t>
            </a:r>
          </a:p>
        </p:txBody>
      </p:sp>
    </p:spTree>
    <p:extLst>
      <p:ext uri="{BB962C8B-B14F-4D97-AF65-F5344CB8AC3E}">
        <p14:creationId xmlns:p14="http://schemas.microsoft.com/office/powerpoint/2010/main" val="15165944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21178683-4C1E-179F-DF84-3D04A107DA3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99520600"/>
              </p:ext>
            </p:extLst>
          </p:nvPr>
        </p:nvGraphicFramePr>
        <p:xfrm>
          <a:off x="810520" y="518882"/>
          <a:ext cx="7775695" cy="4266672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416763">
                  <a:extLst>
                    <a:ext uri="{9D8B030D-6E8A-4147-A177-3AD203B41FA5}">
                      <a16:colId xmlns:a16="http://schemas.microsoft.com/office/drawing/2014/main" val="630714373"/>
                    </a:ext>
                  </a:extLst>
                </a:gridCol>
                <a:gridCol w="728752">
                  <a:extLst>
                    <a:ext uri="{9D8B030D-6E8A-4147-A177-3AD203B41FA5}">
                      <a16:colId xmlns:a16="http://schemas.microsoft.com/office/drawing/2014/main" val="2334880184"/>
                    </a:ext>
                  </a:extLst>
                </a:gridCol>
                <a:gridCol w="787593">
                  <a:extLst>
                    <a:ext uri="{9D8B030D-6E8A-4147-A177-3AD203B41FA5}">
                      <a16:colId xmlns:a16="http://schemas.microsoft.com/office/drawing/2014/main" val="377910219"/>
                    </a:ext>
                  </a:extLst>
                </a:gridCol>
                <a:gridCol w="760435">
                  <a:extLst>
                    <a:ext uri="{9D8B030D-6E8A-4147-A177-3AD203B41FA5}">
                      <a16:colId xmlns:a16="http://schemas.microsoft.com/office/drawing/2014/main" val="1513624534"/>
                    </a:ext>
                  </a:extLst>
                </a:gridCol>
                <a:gridCol w="1366973">
                  <a:extLst>
                    <a:ext uri="{9D8B030D-6E8A-4147-A177-3AD203B41FA5}">
                      <a16:colId xmlns:a16="http://schemas.microsoft.com/office/drawing/2014/main" val="890370257"/>
                    </a:ext>
                  </a:extLst>
                </a:gridCol>
                <a:gridCol w="2715179">
                  <a:extLst>
                    <a:ext uri="{9D8B030D-6E8A-4147-A177-3AD203B41FA5}">
                      <a16:colId xmlns:a16="http://schemas.microsoft.com/office/drawing/2014/main" val="579366324"/>
                    </a:ext>
                  </a:extLst>
                </a:gridCol>
              </a:tblGrid>
              <a:tr h="278544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Patient</a:t>
                      </a:r>
                    </a:p>
                    <a:p>
                      <a:pPr algn="ctr"/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g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Gender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Group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Mayo endoscopi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Treatment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91501525"/>
                  </a:ext>
                </a:extLst>
              </a:tr>
              <a:tr h="238502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aUC1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20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2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Mesalazin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440057265"/>
                  </a:ext>
                </a:extLst>
              </a:tr>
              <a:tr h="22668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</a:rPr>
                        <a:t>aUC2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5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3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dalimumab+Azathioprine+Acenocuramol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1381508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</a:rPr>
                        <a:t>aUC3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3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zathioprine+Mesalazin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06518034"/>
                  </a:ext>
                </a:extLst>
              </a:tr>
              <a:tr h="271021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</a:rPr>
                        <a:t>aUC4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4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Tofacitinib+Mesalazin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80092367"/>
                  </a:ext>
                </a:extLst>
              </a:tr>
              <a:tr h="249382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</a:rPr>
                        <a:t>aUC5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2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Vedolizumab+Mesalazin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47438631"/>
                  </a:ext>
                </a:extLst>
              </a:tr>
              <a:tr h="257694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</a:rPr>
                        <a:t>aUC6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5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Infliximab+Mesalazin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58584256"/>
                  </a:ext>
                </a:extLst>
              </a:tr>
              <a:tr h="257695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</a:rPr>
                        <a:t>aUC7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4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3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Mesalazin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70423136"/>
                  </a:ext>
                </a:extLst>
              </a:tr>
              <a:tr h="23275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</a:rPr>
                        <a:t>aUC8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4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Golimumab+Mesalazin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65947714"/>
                  </a:ext>
                </a:extLst>
              </a:tr>
              <a:tr h="221672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</a:rPr>
                        <a:t>aUC9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7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dalimumab+Mesalazin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62270837"/>
                  </a:ext>
                </a:extLst>
              </a:tr>
              <a:tr h="235527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</a:rPr>
                        <a:t>aUC10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3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2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dalimumab+Mesalazine+Azathioprin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50220081"/>
                  </a:ext>
                </a:extLst>
              </a:tr>
              <a:tr h="224443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</a:rPr>
                        <a:t>aUC11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3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3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Mesalazin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71262542"/>
                  </a:ext>
                </a:extLst>
              </a:tr>
              <a:tr h="221672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</a:rPr>
                        <a:t>aUC12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5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3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G</a:t>
                      </a: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olimimab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+</a:t>
                      </a:r>
                      <a:r>
                        <a:rPr lang="es-ES" sz="1000" dirty="0" err="1">
                          <a:latin typeface="Palatino Linotype" panose="02040502050505030304" pitchFamily="18" charset="0"/>
                        </a:rPr>
                        <a:t>Methotrexate</a:t>
                      </a:r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 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8159637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</a:rPr>
                        <a:t>aUC13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4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2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Tofacitinib+Mesalazin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00891407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</a:rPr>
                        <a:t>aUC1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60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Mal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2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zathioprine+Mesalazine+Budesonid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38289879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</a:rPr>
                        <a:t>aUC15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64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 err="1">
                          <a:latin typeface="Palatino Linotype" panose="02040502050505030304" pitchFamily="18" charset="0"/>
                        </a:rPr>
                        <a:t>Femal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 err="1">
                          <a:latin typeface="Palatino Linotype" panose="02040502050505030304" pitchFamily="18" charset="0"/>
                        </a:rPr>
                        <a:t>a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2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Mesalazine+Prednisolone+Fluoxetin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37547178"/>
                  </a:ext>
                </a:extLst>
              </a:tr>
            </a:tbl>
          </a:graphicData>
        </a:graphic>
      </p:graphicFrame>
      <p:sp>
        <p:nvSpPr>
          <p:cNvPr id="6" name="CuadroTexto 5">
            <a:extLst>
              <a:ext uri="{FF2B5EF4-FFF2-40B4-BE49-F238E27FC236}">
                <a16:creationId xmlns:a16="http://schemas.microsoft.com/office/drawing/2014/main" id="{87A3E376-5DFE-2242-A1B3-A79B5431112F}"/>
              </a:ext>
            </a:extLst>
          </p:cNvPr>
          <p:cNvSpPr txBox="1"/>
          <p:nvPr/>
        </p:nvSpPr>
        <p:spPr>
          <a:xfrm>
            <a:off x="886967" y="4977676"/>
            <a:ext cx="7699247" cy="4154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50" dirty="0">
                <a:latin typeface="Palatino Linotype" panose="02040502050505030304" pitchFamily="18" charset="0"/>
              </a:rPr>
              <a:t>Supplementary Table S2. Demographics of all the patients with active ulcerative colitis (</a:t>
            </a:r>
            <a:r>
              <a:rPr lang="en-US" sz="1050" dirty="0" err="1">
                <a:latin typeface="Palatino Linotype" panose="02040502050505030304" pitchFamily="18" charset="0"/>
              </a:rPr>
              <a:t>aUC</a:t>
            </a:r>
            <a:r>
              <a:rPr lang="en-US" sz="1050" dirty="0">
                <a:latin typeface="Palatino Linotype" panose="02040502050505030304" pitchFamily="18" charset="0"/>
              </a:rPr>
              <a:t>) including gender, age, Mayo Endoscopic score and treatment.</a:t>
            </a:r>
          </a:p>
        </p:txBody>
      </p:sp>
    </p:spTree>
    <p:extLst>
      <p:ext uri="{BB962C8B-B14F-4D97-AF65-F5344CB8AC3E}">
        <p14:creationId xmlns:p14="http://schemas.microsoft.com/office/powerpoint/2010/main" val="22512967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9C5A692B-0030-5FF2-96AE-5AE03C6A07E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10673485"/>
              </p:ext>
            </p:extLst>
          </p:nvPr>
        </p:nvGraphicFramePr>
        <p:xfrm>
          <a:off x="897773" y="479718"/>
          <a:ext cx="7094163" cy="411427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00942">
                  <a:extLst>
                    <a:ext uri="{9D8B030D-6E8A-4147-A177-3AD203B41FA5}">
                      <a16:colId xmlns:a16="http://schemas.microsoft.com/office/drawing/2014/main" val="630714373"/>
                    </a:ext>
                  </a:extLst>
                </a:gridCol>
                <a:gridCol w="669176">
                  <a:extLst>
                    <a:ext uri="{9D8B030D-6E8A-4147-A177-3AD203B41FA5}">
                      <a16:colId xmlns:a16="http://schemas.microsoft.com/office/drawing/2014/main" val="2334880184"/>
                    </a:ext>
                  </a:extLst>
                </a:gridCol>
                <a:gridCol w="723207">
                  <a:extLst>
                    <a:ext uri="{9D8B030D-6E8A-4147-A177-3AD203B41FA5}">
                      <a16:colId xmlns:a16="http://schemas.microsoft.com/office/drawing/2014/main" val="377910219"/>
                    </a:ext>
                  </a:extLst>
                </a:gridCol>
                <a:gridCol w="556953">
                  <a:extLst>
                    <a:ext uri="{9D8B030D-6E8A-4147-A177-3AD203B41FA5}">
                      <a16:colId xmlns:a16="http://schemas.microsoft.com/office/drawing/2014/main" val="1513624534"/>
                    </a:ext>
                  </a:extLst>
                </a:gridCol>
                <a:gridCol w="1117917">
                  <a:extLst>
                    <a:ext uri="{9D8B030D-6E8A-4147-A177-3AD203B41FA5}">
                      <a16:colId xmlns:a16="http://schemas.microsoft.com/office/drawing/2014/main" val="890370257"/>
                    </a:ext>
                  </a:extLst>
                </a:gridCol>
                <a:gridCol w="2725968">
                  <a:extLst>
                    <a:ext uri="{9D8B030D-6E8A-4147-A177-3AD203B41FA5}">
                      <a16:colId xmlns:a16="http://schemas.microsoft.com/office/drawing/2014/main" val="579366324"/>
                    </a:ext>
                  </a:extLst>
                </a:gridCol>
              </a:tblGrid>
              <a:tr h="162344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Patient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g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Gender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Group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Mayo endoscopi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Treatment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91501525"/>
                  </a:ext>
                </a:extLst>
              </a:tr>
              <a:tr h="238502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qUC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4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5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Mal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/>
                        <a:t>q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0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E</a:t>
                      </a: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trolizumab+Azathioprin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40057265"/>
                  </a:ext>
                </a:extLst>
              </a:tr>
              <a:tr h="22668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qUC2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4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8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Mal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/>
                        <a:t>q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0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V</a:t>
                      </a: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edolizumab+Azathioprin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1381508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qUC3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42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Mal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/>
                        <a:t>q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0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A</a:t>
                      </a: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dalimumab+Mesalazin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06518034"/>
                  </a:ext>
                </a:extLst>
              </a:tr>
              <a:tr h="271021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qUC4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6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5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/>
                        <a:t>q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0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I</a:t>
                      </a: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nfliximab+</a:t>
                      </a:r>
                      <a:r>
                        <a:rPr lang="en-US" sz="1000" b="0" i="0" dirty="0" err="1">
                          <a:solidFill>
                            <a:srgbClr val="0C0C0C"/>
                          </a:solidFill>
                          <a:effectLst/>
                          <a:latin typeface="Palatino Linotype" panose="02040502050505030304" pitchFamily="18" charset="0"/>
                        </a:rPr>
                        <a:t>Acetyl</a:t>
                      </a:r>
                      <a:r>
                        <a:rPr lang="en-US" sz="1000" b="0" i="0" dirty="0">
                          <a:solidFill>
                            <a:srgbClr val="181818"/>
                          </a:solidFill>
                          <a:effectLst/>
                          <a:latin typeface="Palatino Linotype" panose="02040502050505030304" pitchFamily="18" charset="0"/>
                        </a:rPr>
                        <a:t> sa</a:t>
                      </a:r>
                      <a:r>
                        <a:rPr lang="en-US" sz="1000" b="0" i="0" dirty="0">
                          <a:solidFill>
                            <a:srgbClr val="242424"/>
                          </a:solidFill>
                          <a:effectLst/>
                          <a:latin typeface="Palatino Linotype" panose="02040502050505030304" pitchFamily="18" charset="0"/>
                        </a:rPr>
                        <a:t>lic</a:t>
                      </a:r>
                      <a:r>
                        <a:rPr lang="en-US" sz="1000" b="0" i="0" dirty="0">
                          <a:solidFill>
                            <a:srgbClr val="181818"/>
                          </a:solidFill>
                          <a:effectLst/>
                          <a:latin typeface="Palatino Linotype" panose="02040502050505030304" pitchFamily="18" charset="0"/>
                        </a:rPr>
                        <a:t>ylic</a:t>
                      </a:r>
                      <a:r>
                        <a:rPr lang="en-US" sz="1000" b="0" i="0" dirty="0">
                          <a:solidFill>
                            <a:srgbClr val="0C0C0C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  <a:r>
                        <a:rPr lang="en-US" sz="1000" b="0" i="0" dirty="0" err="1">
                          <a:solidFill>
                            <a:srgbClr val="0C0C0C"/>
                          </a:solidFill>
                          <a:effectLst/>
                          <a:latin typeface="Palatino Linotype" panose="02040502050505030304" pitchFamily="18" charset="0"/>
                        </a:rPr>
                        <a:t>acid+atorvastatin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80092367"/>
                  </a:ext>
                </a:extLst>
              </a:tr>
              <a:tr h="249382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qUC5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4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/>
                        <a:t>q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/>
                        <a:t>Untreate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47438631"/>
                  </a:ext>
                </a:extLst>
              </a:tr>
              <a:tr h="257694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qUC6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6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5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/>
                        <a:t>q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0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/>
                        <a:t>Untreate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58584256"/>
                  </a:ext>
                </a:extLst>
              </a:tr>
              <a:tr h="257695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qUC7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5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/>
                        <a:t>q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V</a:t>
                      </a: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edolizumab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0423136"/>
                  </a:ext>
                </a:extLst>
              </a:tr>
              <a:tr h="23275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qUC8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5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9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/>
                        <a:t>q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dalimumab+Azathioprine+Mesalazine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 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65947714"/>
                  </a:ext>
                </a:extLst>
              </a:tr>
              <a:tr h="221672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qUC9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3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/>
                        <a:t>q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Mesalazine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 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62270837"/>
                  </a:ext>
                </a:extLst>
              </a:tr>
              <a:tr h="235527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qUC1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66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/>
                        <a:t>q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0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zathioprine+Mesalazine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 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50220081"/>
                  </a:ext>
                </a:extLst>
              </a:tr>
              <a:tr h="224443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qUC1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3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/>
                        <a:t>q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Mesalazin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71262542"/>
                  </a:ext>
                </a:extLst>
              </a:tr>
              <a:tr h="221672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qUC12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58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/>
                        <a:t>q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0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Mesalazine</a:t>
                      </a:r>
                      <a:r>
                        <a:rPr lang="en-US" sz="1000">
                          <a:latin typeface="Palatino Linotype" panose="02040502050505030304" pitchFamily="18" charset="0"/>
                        </a:rPr>
                        <a:t> +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ercaptopurin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8159637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qUC13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54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/>
                        <a:t>q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0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Mesalazin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00891407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qUC14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6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/>
                        <a:t>q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1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Mesalazin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60449634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qUC15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45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/>
                        <a:t>qUC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0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</a:rPr>
                        <a:t>Mesalazine</a:t>
                      </a: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+omeoprazol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90348981"/>
                  </a:ext>
                </a:extLst>
              </a:tr>
            </a:tbl>
          </a:graphicData>
        </a:graphic>
      </p:graphicFrame>
      <p:sp>
        <p:nvSpPr>
          <p:cNvPr id="6" name="CuadroTexto 5">
            <a:extLst>
              <a:ext uri="{FF2B5EF4-FFF2-40B4-BE49-F238E27FC236}">
                <a16:creationId xmlns:a16="http://schemas.microsoft.com/office/drawing/2014/main" id="{5A88BC88-3F25-0631-679B-338AD453D849}"/>
              </a:ext>
            </a:extLst>
          </p:cNvPr>
          <p:cNvSpPr txBox="1"/>
          <p:nvPr/>
        </p:nvSpPr>
        <p:spPr>
          <a:xfrm>
            <a:off x="749808" y="4840516"/>
            <a:ext cx="8394192" cy="4154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50" dirty="0">
                <a:latin typeface="Palatino Linotype" panose="02040502050505030304" pitchFamily="18" charset="0"/>
              </a:rPr>
              <a:t>Supplementary Table S3. Demographics of all the patients with quiescent ulcerative colitis (</a:t>
            </a:r>
            <a:r>
              <a:rPr lang="en-US" sz="1050" dirty="0" err="1">
                <a:latin typeface="Palatino Linotype" panose="02040502050505030304" pitchFamily="18" charset="0"/>
              </a:rPr>
              <a:t>qUC</a:t>
            </a:r>
            <a:r>
              <a:rPr lang="en-US" sz="1050" dirty="0">
                <a:latin typeface="Palatino Linotype" panose="02040502050505030304" pitchFamily="18" charset="0"/>
              </a:rPr>
              <a:t>) including gender, age, Mayo Endoscopic score and treatment</a:t>
            </a:r>
            <a:endParaRPr lang="en-US" sz="1050" dirty="0"/>
          </a:p>
        </p:txBody>
      </p:sp>
    </p:spTree>
    <p:extLst>
      <p:ext uri="{BB962C8B-B14F-4D97-AF65-F5344CB8AC3E}">
        <p14:creationId xmlns:p14="http://schemas.microsoft.com/office/powerpoint/2010/main" val="27826130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8DF01320-05E0-0B10-A6F6-81DB9DE453F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26640594"/>
              </p:ext>
            </p:extLst>
          </p:nvPr>
        </p:nvGraphicFramePr>
        <p:xfrm>
          <a:off x="778901" y="488862"/>
          <a:ext cx="7140028" cy="396187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00942">
                  <a:extLst>
                    <a:ext uri="{9D8B030D-6E8A-4147-A177-3AD203B41FA5}">
                      <a16:colId xmlns:a16="http://schemas.microsoft.com/office/drawing/2014/main" val="630714373"/>
                    </a:ext>
                  </a:extLst>
                </a:gridCol>
                <a:gridCol w="669176">
                  <a:extLst>
                    <a:ext uri="{9D8B030D-6E8A-4147-A177-3AD203B41FA5}">
                      <a16:colId xmlns:a16="http://schemas.microsoft.com/office/drawing/2014/main" val="2334880184"/>
                    </a:ext>
                  </a:extLst>
                </a:gridCol>
                <a:gridCol w="723207">
                  <a:extLst>
                    <a:ext uri="{9D8B030D-6E8A-4147-A177-3AD203B41FA5}">
                      <a16:colId xmlns:a16="http://schemas.microsoft.com/office/drawing/2014/main" val="377910219"/>
                    </a:ext>
                  </a:extLst>
                </a:gridCol>
                <a:gridCol w="556953">
                  <a:extLst>
                    <a:ext uri="{9D8B030D-6E8A-4147-A177-3AD203B41FA5}">
                      <a16:colId xmlns:a16="http://schemas.microsoft.com/office/drawing/2014/main" val="1513624534"/>
                    </a:ext>
                  </a:extLst>
                </a:gridCol>
                <a:gridCol w="1163782">
                  <a:extLst>
                    <a:ext uri="{9D8B030D-6E8A-4147-A177-3AD203B41FA5}">
                      <a16:colId xmlns:a16="http://schemas.microsoft.com/office/drawing/2014/main" val="890370257"/>
                    </a:ext>
                  </a:extLst>
                </a:gridCol>
                <a:gridCol w="2725968">
                  <a:extLst>
                    <a:ext uri="{9D8B030D-6E8A-4147-A177-3AD203B41FA5}">
                      <a16:colId xmlns:a16="http://schemas.microsoft.com/office/drawing/2014/main" val="579366324"/>
                    </a:ext>
                  </a:extLst>
                </a:gridCol>
              </a:tblGrid>
              <a:tr h="162344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Patient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g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Gender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Group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SES-CD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Treatment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91501525"/>
                  </a:ext>
                </a:extLst>
              </a:tr>
              <a:tr h="238502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aCD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4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5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5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U</a:t>
                      </a: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stekinumab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40057265"/>
                  </a:ext>
                </a:extLst>
              </a:tr>
              <a:tr h="22668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aCD2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6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3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E</a:t>
                      </a: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trolizumab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1381508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aCD3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6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4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Ustekimumab+Methotrexat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06518034"/>
                  </a:ext>
                </a:extLst>
              </a:tr>
              <a:tr h="271021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aCD4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28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4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A</a:t>
                      </a: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dalimumab+Mesalazin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80092367"/>
                  </a:ext>
                </a:extLst>
              </a:tr>
              <a:tr h="249382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aCD5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4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1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A</a:t>
                      </a: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dalimumab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47438631"/>
                  </a:ext>
                </a:extLst>
              </a:tr>
              <a:tr h="257694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aCD6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2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1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V</a:t>
                      </a: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edolizumab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58584256"/>
                  </a:ext>
                </a:extLst>
              </a:tr>
              <a:tr h="257695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aCD7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23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6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Mesalazin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0423136"/>
                  </a:ext>
                </a:extLst>
              </a:tr>
              <a:tr h="23275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aCD8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3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6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000" dirty="0" err="1">
                          <a:latin typeface="Palatino Linotype" panose="02040502050505030304" pitchFamily="18" charset="0"/>
                        </a:rPr>
                        <a:t>Infliximab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65947714"/>
                  </a:ext>
                </a:extLst>
              </a:tr>
              <a:tr h="221672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aCD9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57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8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Certolizumab pegol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62270837"/>
                  </a:ext>
                </a:extLst>
              </a:tr>
              <a:tr h="235527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aCD1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5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2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4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A</a:t>
                      </a: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dalimumab+</a:t>
                      </a:r>
                      <a:r>
                        <a:rPr lang="en-US" sz="1000" b="0" i="0" kern="12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levetiracetam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50220081"/>
                  </a:ext>
                </a:extLst>
              </a:tr>
              <a:tr h="224443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aCD1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5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9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3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Prednisolon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71262542"/>
                  </a:ext>
                </a:extLst>
              </a:tr>
              <a:tr h="221672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aCD12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52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5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Prednisolon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8159637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aCD13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6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6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2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zathioprine+Mesalazin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00891407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aCD14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5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8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4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U</a:t>
                      </a: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stekinumab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60449634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aCD15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2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a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4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I</a:t>
                      </a: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nfliximab+Budesonid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90348981"/>
                  </a:ext>
                </a:extLst>
              </a:tr>
            </a:tbl>
          </a:graphicData>
        </a:graphic>
      </p:graphicFrame>
      <p:sp>
        <p:nvSpPr>
          <p:cNvPr id="6" name="CuadroTexto 5">
            <a:extLst>
              <a:ext uri="{FF2B5EF4-FFF2-40B4-BE49-F238E27FC236}">
                <a16:creationId xmlns:a16="http://schemas.microsoft.com/office/drawing/2014/main" id="{79C3D5AE-E358-0F59-CC88-27622E03C74F}"/>
              </a:ext>
            </a:extLst>
          </p:cNvPr>
          <p:cNvSpPr txBox="1"/>
          <p:nvPr/>
        </p:nvSpPr>
        <p:spPr>
          <a:xfrm>
            <a:off x="649224" y="4546568"/>
            <a:ext cx="7754112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50" dirty="0">
                <a:latin typeface="Palatino Linotype" panose="02040502050505030304" pitchFamily="18" charset="0"/>
              </a:rPr>
              <a:t>Supplementary Table S4. Demographics of all the patients with active Crohn´s disease (</a:t>
            </a:r>
            <a:r>
              <a:rPr lang="en-US" sz="1050" dirty="0" err="1">
                <a:latin typeface="Palatino Linotype" panose="02040502050505030304" pitchFamily="18" charset="0"/>
              </a:rPr>
              <a:t>aCD</a:t>
            </a:r>
            <a:r>
              <a:rPr lang="en-US" sz="1050" dirty="0">
                <a:latin typeface="Palatino Linotype" panose="02040502050505030304" pitchFamily="18" charset="0"/>
              </a:rPr>
              <a:t>) including gender, age, simplified endoscopic activity score for Crohn´s disease (SES-CD), and treatment.</a:t>
            </a:r>
          </a:p>
        </p:txBody>
      </p:sp>
    </p:spTree>
    <p:extLst>
      <p:ext uri="{BB962C8B-B14F-4D97-AF65-F5344CB8AC3E}">
        <p14:creationId xmlns:p14="http://schemas.microsoft.com/office/powerpoint/2010/main" val="226395648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6C8F4397-6CC9-D878-F744-D2346DD1F0D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89027531"/>
              </p:ext>
            </p:extLst>
          </p:nvPr>
        </p:nvGraphicFramePr>
        <p:xfrm>
          <a:off x="897773" y="479718"/>
          <a:ext cx="7140028" cy="396187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00942">
                  <a:extLst>
                    <a:ext uri="{9D8B030D-6E8A-4147-A177-3AD203B41FA5}">
                      <a16:colId xmlns:a16="http://schemas.microsoft.com/office/drawing/2014/main" val="630714373"/>
                    </a:ext>
                  </a:extLst>
                </a:gridCol>
                <a:gridCol w="669176">
                  <a:extLst>
                    <a:ext uri="{9D8B030D-6E8A-4147-A177-3AD203B41FA5}">
                      <a16:colId xmlns:a16="http://schemas.microsoft.com/office/drawing/2014/main" val="2334880184"/>
                    </a:ext>
                  </a:extLst>
                </a:gridCol>
                <a:gridCol w="723207">
                  <a:extLst>
                    <a:ext uri="{9D8B030D-6E8A-4147-A177-3AD203B41FA5}">
                      <a16:colId xmlns:a16="http://schemas.microsoft.com/office/drawing/2014/main" val="377910219"/>
                    </a:ext>
                  </a:extLst>
                </a:gridCol>
                <a:gridCol w="556953">
                  <a:extLst>
                    <a:ext uri="{9D8B030D-6E8A-4147-A177-3AD203B41FA5}">
                      <a16:colId xmlns:a16="http://schemas.microsoft.com/office/drawing/2014/main" val="1513624534"/>
                    </a:ext>
                  </a:extLst>
                </a:gridCol>
                <a:gridCol w="1163782">
                  <a:extLst>
                    <a:ext uri="{9D8B030D-6E8A-4147-A177-3AD203B41FA5}">
                      <a16:colId xmlns:a16="http://schemas.microsoft.com/office/drawing/2014/main" val="890370257"/>
                    </a:ext>
                  </a:extLst>
                </a:gridCol>
                <a:gridCol w="2725968">
                  <a:extLst>
                    <a:ext uri="{9D8B030D-6E8A-4147-A177-3AD203B41FA5}">
                      <a16:colId xmlns:a16="http://schemas.microsoft.com/office/drawing/2014/main" val="579366324"/>
                    </a:ext>
                  </a:extLst>
                </a:gridCol>
              </a:tblGrid>
              <a:tr h="162344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Patient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Ag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Gender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Group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SES-CD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Treatment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91501525"/>
                  </a:ext>
                </a:extLst>
              </a:tr>
              <a:tr h="238502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/>
                        <a:t>qCD1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6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q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A</a:t>
                      </a: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dalimumab+Azathioprin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40057265"/>
                  </a:ext>
                </a:extLst>
              </a:tr>
              <a:tr h="22668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qCD2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44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q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I</a:t>
                      </a: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nfliximab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1381508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qCD3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3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4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q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A</a:t>
                      </a: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dalimumab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06518034"/>
                  </a:ext>
                </a:extLst>
              </a:tr>
              <a:tr h="271021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qCD4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44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q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Mesalazin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80092367"/>
                  </a:ext>
                </a:extLst>
              </a:tr>
              <a:tr h="249382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qCD5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4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6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q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Azathioprin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47438631"/>
                  </a:ext>
                </a:extLst>
              </a:tr>
              <a:tr h="257694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qCD6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4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4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q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2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I</a:t>
                      </a: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nfliximab+Azathioprin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58584256"/>
                  </a:ext>
                </a:extLst>
              </a:tr>
              <a:tr h="257695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qCD7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4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7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q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Azathioprin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0423136"/>
                  </a:ext>
                </a:extLst>
              </a:tr>
              <a:tr h="23275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qCD8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7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8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q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Methotrexate+glucocorticoids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65947714"/>
                  </a:ext>
                </a:extLst>
              </a:tr>
              <a:tr h="221672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qCD9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7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3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q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Infliximab+Azathioprine+Mesalazin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62270837"/>
                  </a:ext>
                </a:extLst>
              </a:tr>
              <a:tr h="235527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qCD10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28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q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U</a:t>
                      </a: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ntreate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50220081"/>
                  </a:ext>
                </a:extLst>
              </a:tr>
              <a:tr h="224443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qCD11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6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6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q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Vedolizumab+Mercaptopurin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71262542"/>
                  </a:ext>
                </a:extLst>
              </a:tr>
              <a:tr h="221672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qCD12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4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q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2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A</a:t>
                      </a: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dalimumab+Azathioprin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8159637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qCD13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7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2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Fe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q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A</a:t>
                      </a: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dalimumab+Methotrexat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00891407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qCD14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6</a:t>
                      </a: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5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Male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q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0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Palatino Linotype" panose="02040502050505030304" pitchFamily="18" charset="0"/>
                        </a:rPr>
                        <a:t>Ustekinumab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60449634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qCD15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56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 err="1">
                          <a:latin typeface="Palatino Linotype" panose="02040502050505030304" pitchFamily="18" charset="0"/>
                        </a:rPr>
                        <a:t>Female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qCD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dirty="0">
                          <a:latin typeface="Palatino Linotype" panose="02040502050505030304" pitchFamily="18" charset="0"/>
                        </a:rPr>
                        <a:t>0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>
                          <a:latin typeface="Palatino Linotype" panose="02040502050505030304" pitchFamily="18" charset="0"/>
                        </a:rPr>
                        <a:t>Mesalazine+salazopyrin</a:t>
                      </a:r>
                      <a:endParaRPr lang="en-US" sz="100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62094578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D2017843-5CE7-5406-5E88-AD8CEF3EDCB4}"/>
              </a:ext>
            </a:extLst>
          </p:cNvPr>
          <p:cNvSpPr txBox="1"/>
          <p:nvPr/>
        </p:nvSpPr>
        <p:spPr>
          <a:xfrm>
            <a:off x="822958" y="4637626"/>
            <a:ext cx="7074131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dirty="0">
                <a:latin typeface="Palatino Linotype" panose="02040502050505030304" pitchFamily="18" charset="0"/>
              </a:rPr>
              <a:t>Supplementary Table S5. Demographics of all the patients with quiescent Crohn’s disease (</a:t>
            </a:r>
            <a:r>
              <a:rPr lang="en-US" sz="1000" dirty="0" err="1">
                <a:latin typeface="Palatino Linotype" panose="02040502050505030304" pitchFamily="18" charset="0"/>
              </a:rPr>
              <a:t>qCD</a:t>
            </a:r>
            <a:r>
              <a:rPr lang="en-US" sz="1000" dirty="0">
                <a:latin typeface="Palatino Linotype" panose="02040502050505030304" pitchFamily="18" charset="0"/>
              </a:rPr>
              <a:t>) including gender, age, simplified endoscopic activity score for Crohn´s disease (SES-CD) and treatment.</a:t>
            </a:r>
          </a:p>
        </p:txBody>
      </p:sp>
    </p:spTree>
    <p:extLst>
      <p:ext uri="{BB962C8B-B14F-4D97-AF65-F5344CB8AC3E}">
        <p14:creationId xmlns:p14="http://schemas.microsoft.com/office/powerpoint/2010/main" val="384396264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7B48F475-234E-20A5-2E78-FE11F035037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93971989"/>
              </p:ext>
            </p:extLst>
          </p:nvPr>
        </p:nvGraphicFramePr>
        <p:xfrm>
          <a:off x="1001699" y="350923"/>
          <a:ext cx="6938620" cy="5469303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734655">
                  <a:extLst>
                    <a:ext uri="{9D8B030D-6E8A-4147-A177-3AD203B41FA5}">
                      <a16:colId xmlns:a16="http://schemas.microsoft.com/office/drawing/2014/main" val="377811727"/>
                    </a:ext>
                  </a:extLst>
                </a:gridCol>
                <a:gridCol w="1734655">
                  <a:extLst>
                    <a:ext uri="{9D8B030D-6E8A-4147-A177-3AD203B41FA5}">
                      <a16:colId xmlns:a16="http://schemas.microsoft.com/office/drawing/2014/main" val="2599000928"/>
                    </a:ext>
                  </a:extLst>
                </a:gridCol>
                <a:gridCol w="1734655">
                  <a:extLst>
                    <a:ext uri="{9D8B030D-6E8A-4147-A177-3AD203B41FA5}">
                      <a16:colId xmlns:a16="http://schemas.microsoft.com/office/drawing/2014/main" val="2160779242"/>
                    </a:ext>
                  </a:extLst>
                </a:gridCol>
                <a:gridCol w="1734655">
                  <a:extLst>
                    <a:ext uri="{9D8B030D-6E8A-4147-A177-3AD203B41FA5}">
                      <a16:colId xmlns:a16="http://schemas.microsoft.com/office/drawing/2014/main" val="1945603584"/>
                    </a:ext>
                  </a:extLst>
                </a:gridCol>
              </a:tblGrid>
              <a:tr h="371767"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Antibody specificity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</a:rPr>
                        <a:t>Fluorochrome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</a:rPr>
                        <a:t>Clone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Manufacturer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21741298"/>
                  </a:ext>
                </a:extLst>
              </a:tr>
              <a:tr h="318596"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CD19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PE-Cy5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MOPC-21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Becton Dickinson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07801880"/>
                  </a:ext>
                </a:extLst>
              </a:tr>
              <a:tr h="318596"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CD19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PECF594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HIBI9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0" dirty="0" err="1">
                          <a:latin typeface="Palatino Linotype" panose="02040502050505030304" pitchFamily="18" charset="0"/>
                        </a:rPr>
                        <a:t>Biolegend</a:t>
                      </a:r>
                      <a:endParaRPr lang="en-US" sz="1050" b="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05128279"/>
                  </a:ext>
                </a:extLst>
              </a:tr>
              <a:tr h="318596"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HLA-DR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BV510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L243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 err="1">
                          <a:latin typeface="Palatino Linotype" panose="02040502050505030304" pitchFamily="18" charset="0"/>
                        </a:rPr>
                        <a:t>Biolegend</a:t>
                      </a:r>
                      <a:endParaRPr lang="en-US" sz="105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59807439"/>
                  </a:ext>
                </a:extLst>
              </a:tr>
              <a:tr h="318596"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CD14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PECF594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M</a:t>
                      </a:r>
                      <a:r>
                        <a:rPr lang="el-GR" sz="1050" dirty="0">
                          <a:latin typeface="Palatino Linotype" panose="02040502050505030304" pitchFamily="18" charset="0"/>
                        </a:rPr>
                        <a:t>ϕ</a:t>
                      </a:r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Pg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Becton Dickinson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21009665"/>
                  </a:ext>
                </a:extLst>
              </a:tr>
              <a:tr h="318596"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CD14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PE-Cy5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TÜK4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 err="1">
                          <a:latin typeface="Palatino Linotype" panose="02040502050505030304" pitchFamily="18" charset="0"/>
                        </a:rPr>
                        <a:t>Miltenyi</a:t>
                      </a:r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050" dirty="0" err="1">
                          <a:latin typeface="Palatino Linotype" panose="02040502050505030304" pitchFamily="18" charset="0"/>
                        </a:rPr>
                        <a:t>Biotec</a:t>
                      </a:r>
                      <a:endParaRPr lang="en-US" sz="105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50408677"/>
                  </a:ext>
                </a:extLst>
              </a:tr>
              <a:tr h="318596"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CD123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FITC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7G3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Becton Dickinson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98176469"/>
                  </a:ext>
                </a:extLst>
              </a:tr>
              <a:tr h="318596"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CD123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APC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6H6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 err="1">
                          <a:latin typeface="Palatino Linotype" panose="02040502050505030304" pitchFamily="18" charset="0"/>
                        </a:rPr>
                        <a:t>Biolegend</a:t>
                      </a:r>
                      <a:endParaRPr lang="en-US" sz="105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40097247"/>
                  </a:ext>
                </a:extLst>
              </a:tr>
              <a:tr h="318596"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CD11c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Alexa Fluor 700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Bu15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 err="1">
                          <a:latin typeface="Palatino Linotype" panose="02040502050505030304" pitchFamily="18" charset="0"/>
                        </a:rPr>
                        <a:t>Biolegend</a:t>
                      </a:r>
                      <a:endParaRPr lang="en-US" sz="105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12398269"/>
                  </a:ext>
                </a:extLst>
              </a:tr>
              <a:tr h="318596"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CD11c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FITC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MJ4-27G12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 err="1">
                          <a:latin typeface="Palatino Linotype" panose="02040502050505030304" pitchFamily="18" charset="0"/>
                        </a:rPr>
                        <a:t>Miltenyi</a:t>
                      </a:r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050" dirty="0" err="1">
                          <a:latin typeface="Palatino Linotype" panose="02040502050505030304" pitchFamily="18" charset="0"/>
                        </a:rPr>
                        <a:t>Biotec</a:t>
                      </a:r>
                      <a:endParaRPr lang="en-US" sz="105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13379557"/>
                  </a:ext>
                </a:extLst>
              </a:tr>
              <a:tr h="318596"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CD141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BV421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AD5-14H12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 err="1">
                          <a:latin typeface="Palatino Linotype" panose="02040502050505030304" pitchFamily="18" charset="0"/>
                        </a:rPr>
                        <a:t>Miltenyi</a:t>
                      </a:r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050" dirty="0" err="1">
                          <a:latin typeface="Palatino Linotype" panose="02040502050505030304" pitchFamily="18" charset="0"/>
                        </a:rPr>
                        <a:t>Biotec</a:t>
                      </a:r>
                      <a:endParaRPr lang="en-US" sz="105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40478603"/>
                  </a:ext>
                </a:extLst>
              </a:tr>
              <a:tr h="318596"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CD1c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PE-Cy7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L161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 err="1">
                          <a:latin typeface="Palatino Linotype" panose="02040502050505030304" pitchFamily="18" charset="0"/>
                        </a:rPr>
                        <a:t>Biolegend</a:t>
                      </a:r>
                      <a:endParaRPr lang="en-US" sz="105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2659247"/>
                  </a:ext>
                </a:extLst>
              </a:tr>
              <a:tr h="318596"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Integrin </a:t>
                      </a:r>
                      <a:r>
                        <a:rPr lang="el-GR" sz="1050" dirty="0">
                          <a:latin typeface="Palatino Linotype" panose="02040502050505030304" pitchFamily="18" charset="0"/>
                        </a:rPr>
                        <a:t>β</a:t>
                      </a:r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7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PE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FIB504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Becton Dickinson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14878639"/>
                  </a:ext>
                </a:extLst>
              </a:tr>
              <a:tr h="318596"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CCR2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BV605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K036C2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 err="1">
                          <a:latin typeface="Palatino Linotype" panose="02040502050505030304" pitchFamily="18" charset="0"/>
                        </a:rPr>
                        <a:t>Biolegend</a:t>
                      </a:r>
                      <a:endParaRPr lang="en-US" sz="105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78223055"/>
                  </a:ext>
                </a:extLst>
              </a:tr>
              <a:tr h="318596"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CCR5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BV711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2D7/CCR5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Becton Dickinson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088903"/>
                  </a:ext>
                </a:extLst>
              </a:tr>
              <a:tr h="318596"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CCR6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BV785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G034E3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 err="1">
                          <a:latin typeface="Palatino Linotype" panose="02040502050505030304" pitchFamily="18" charset="0"/>
                        </a:rPr>
                        <a:t>Biolegend</a:t>
                      </a:r>
                      <a:endParaRPr lang="en-US" sz="1050" dirty="0">
                        <a:latin typeface="Palatino Linotype" panose="0204050205050503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01081245"/>
                  </a:ext>
                </a:extLst>
              </a:tr>
              <a:tr h="318596"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CCR9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APC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567976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latin typeface="Palatino Linotype" panose="02040502050505030304" pitchFamily="18" charset="0"/>
                        </a:rPr>
                        <a:t>Becton Dickinson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61765610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A0729588-0453-2B86-FD08-634DA0C1A684}"/>
              </a:ext>
            </a:extLst>
          </p:cNvPr>
          <p:cNvSpPr txBox="1"/>
          <p:nvPr/>
        </p:nvSpPr>
        <p:spPr>
          <a:xfrm>
            <a:off x="915434" y="5914967"/>
            <a:ext cx="76560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Palatino Linotype" panose="02040502050505030304" pitchFamily="18" charset="0"/>
              </a:rPr>
              <a:t>Supplementary table S6. </a:t>
            </a:r>
            <a:r>
              <a:rPr lang="en-US" sz="1000" b="0" i="0" u="none" strike="noStrike" baseline="0" dirty="0">
                <a:latin typeface="Palatino Linotype" panose="02040502050505030304" pitchFamily="18" charset="0"/>
              </a:rPr>
              <a:t>Specificity, clone, fluorochrome and manufacturer of the different monoclonal antibodies used in this work.</a:t>
            </a:r>
            <a:endParaRPr lang="en-US" sz="10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5908616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686</TotalTime>
  <Words>868</Words>
  <Application>Microsoft Office PowerPoint</Application>
  <PresentationFormat>On-screen Show (4:3)</PresentationFormat>
  <Paragraphs>538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Palatino Linotype</vt:lpstr>
      <vt:lpstr>Tema de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Irene soleto fernandez</dc:creator>
  <cp:lastModifiedBy>MDPI</cp:lastModifiedBy>
  <cp:revision>12</cp:revision>
  <dcterms:created xsi:type="dcterms:W3CDTF">2023-03-03T09:14:06Z</dcterms:created>
  <dcterms:modified xsi:type="dcterms:W3CDTF">2023-10-16T02:19:59Z</dcterms:modified>
</cp:coreProperties>
</file>